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4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8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6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6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4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0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0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5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4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80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2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1147135" y="609600"/>
            <a:ext cx="21643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   M   1     2     3    4      5    6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1" name="表格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5681579"/>
              </p:ext>
            </p:extLst>
          </p:nvPr>
        </p:nvGraphicFramePr>
        <p:xfrm>
          <a:off x="3595407" y="969640"/>
          <a:ext cx="4032448" cy="1453294"/>
        </p:xfrm>
        <a:graphic>
          <a:graphicData uri="http://schemas.openxmlformats.org/drawingml/2006/table">
            <a:tbl>
              <a:tblPr/>
              <a:tblGrid>
                <a:gridCol w="258762"/>
                <a:gridCol w="715962"/>
                <a:gridCol w="808038"/>
                <a:gridCol w="477838"/>
                <a:gridCol w="1771848"/>
              </a:tblGrid>
              <a:tr h="1814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esults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&gt;Tn620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ree plasmid (s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ree plasmid  (tra+Tn6206)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r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Tn6206-&gt;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&gt;Tn620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Free plasmid (</a:t>
                      </a:r>
                      <a:r>
                        <a:rPr lang="en-US" sz="1100" b="0" i="0" u="none" strike="noStrike" kern="1200" dirty="0" err="1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tra</a:t>
                      </a: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-onl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Free plasmid (Tn6206 onl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46" name="Picture 45" descr="2013-4-7 pcr for bjab07104.jpg"/>
          <p:cNvPicPr>
            <a:picLocks noChangeAspect="1"/>
          </p:cNvPicPr>
          <p:nvPr/>
        </p:nvPicPr>
        <p:blipFill>
          <a:blip r:embed="rId2" cstate="print">
            <a:lum bright="-20000"/>
          </a:blip>
          <a:srcRect l="17240" t="15350" r="59094" b="55250"/>
          <a:stretch>
            <a:fillRect/>
          </a:stretch>
        </p:blipFill>
        <p:spPr>
          <a:xfrm>
            <a:off x="1282728" y="969640"/>
            <a:ext cx="2028782" cy="201622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11231" y="29765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11231" y="6010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43000" y="3633936"/>
            <a:ext cx="21643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   M   1     2     3    4      5    6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表格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527632"/>
              </p:ext>
            </p:extLst>
          </p:nvPr>
        </p:nvGraphicFramePr>
        <p:xfrm>
          <a:off x="3595407" y="3993976"/>
          <a:ext cx="4032448" cy="1453294"/>
        </p:xfrm>
        <a:graphic>
          <a:graphicData uri="http://schemas.openxmlformats.org/drawingml/2006/table">
            <a:tbl>
              <a:tblPr/>
              <a:tblGrid>
                <a:gridCol w="258762"/>
                <a:gridCol w="715962"/>
                <a:gridCol w="808038"/>
                <a:gridCol w="477838"/>
                <a:gridCol w="1771848"/>
              </a:tblGrid>
              <a:tr h="1814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esults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&gt;Tn620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ree plasmid (s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ree plasmid  (tra+Tn6206)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r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Tn6206-&gt;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tegrated (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a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&gt;Tn620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Free plasmid (</a:t>
                      </a:r>
                      <a:r>
                        <a:rPr lang="en-US" sz="1100" b="0" i="0" u="none" strike="noStrike" kern="1200" dirty="0" err="1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tra</a:t>
                      </a: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-onl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L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J-pR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000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Free plasmid (Tn6206 onl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12" name="Picture 11" descr="2013-4-7 pcr for bjab07104.jpg"/>
          <p:cNvPicPr>
            <a:picLocks noChangeAspect="1"/>
          </p:cNvPicPr>
          <p:nvPr/>
        </p:nvPicPr>
        <p:blipFill>
          <a:blip r:embed="rId2" cstate="print">
            <a:lum bright="-20000"/>
          </a:blip>
          <a:srcRect l="40906" t="15350" r="35720" b="55250"/>
          <a:stretch>
            <a:fillRect/>
          </a:stretch>
        </p:blipFill>
        <p:spPr>
          <a:xfrm>
            <a:off x="1282728" y="3993976"/>
            <a:ext cx="2003666" cy="201622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539623" y="2553816"/>
            <a:ext cx="220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emplate: BJAB07104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611631" y="5578152"/>
            <a:ext cx="2085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emplate: BJAB0868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S1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2898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70</Words>
  <Application>Microsoft Office PowerPoint</Application>
  <PresentationFormat>On-screen Show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n Li</dc:creator>
  <cp:lastModifiedBy>Quan Li</cp:lastModifiedBy>
  <cp:revision>2</cp:revision>
  <dcterms:created xsi:type="dcterms:W3CDTF">2013-05-15T20:10:55Z</dcterms:created>
  <dcterms:modified xsi:type="dcterms:W3CDTF">2013-05-15T20:33:37Z</dcterms:modified>
</cp:coreProperties>
</file>